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西村 優輝" initials="西村" lastIdx="1" clrIdx="0">
    <p:extLst>
      <p:ext uri="{19B8F6BF-5375-455C-9EA6-DF929625EA0E}">
        <p15:presenceInfo xmlns:p15="http://schemas.microsoft.com/office/powerpoint/2012/main" userId="S::K154564@naramed-u.ac.jp::7d09b080-ae51-4f55-8bca-2b9e67a10b3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97402" autoAdjust="0"/>
  </p:normalViewPr>
  <p:slideViewPr>
    <p:cSldViewPr snapToGrid="0">
      <p:cViewPr varScale="1">
        <p:scale>
          <a:sx n="68" d="100"/>
          <a:sy n="68" d="100"/>
        </p:scale>
        <p:origin x="268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109" d="100"/>
          <a:sy n="109" d="100"/>
        </p:scale>
        <p:origin x="3372" y="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irofumi HITOMI" userId="7f0fc49cc38f80df" providerId="LiveId" clId="{3A26AE82-3AEE-4B0A-AFBA-F08F7C421DB0}"/>
    <pc:docChg chg="undo custSel addSld modSld">
      <pc:chgData name="Hirofumi HITOMI" userId="7f0fc49cc38f80df" providerId="LiveId" clId="{3A26AE82-3AEE-4B0A-AFBA-F08F7C421DB0}" dt="2024-05-20T00:50:20.818" v="68" actId="20577"/>
      <pc:docMkLst>
        <pc:docMk/>
      </pc:docMkLst>
      <pc:sldChg chg="addSp modSp mod">
        <pc:chgData name="Hirofumi HITOMI" userId="7f0fc49cc38f80df" providerId="LiveId" clId="{3A26AE82-3AEE-4B0A-AFBA-F08F7C421DB0}" dt="2024-05-20T00:41:10.700" v="67" actId="1076"/>
        <pc:sldMkLst>
          <pc:docMk/>
          <pc:sldMk cId="4207108356" sldId="257"/>
        </pc:sldMkLst>
        <pc:spChg chg="add mod">
          <ac:chgData name="Hirofumi HITOMI" userId="7f0fc49cc38f80df" providerId="LiveId" clId="{3A26AE82-3AEE-4B0A-AFBA-F08F7C421DB0}" dt="2024-05-20T00:33:08.017" v="21" actId="20577"/>
          <ac:spMkLst>
            <pc:docMk/>
            <pc:sldMk cId="4207108356" sldId="257"/>
            <ac:spMk id="5" creationId="{A2473A78-E04B-5042-7E1C-0128227F7A80}"/>
          </ac:spMkLst>
        </pc:spChg>
        <pc:spChg chg="add mod">
          <ac:chgData name="Hirofumi HITOMI" userId="7f0fc49cc38f80df" providerId="LiveId" clId="{3A26AE82-3AEE-4B0A-AFBA-F08F7C421DB0}" dt="2024-05-20T00:32:11.101" v="0"/>
          <ac:spMkLst>
            <pc:docMk/>
            <pc:sldMk cId="4207108356" sldId="257"/>
            <ac:spMk id="17" creationId="{015F0438-3DCF-8D55-1CCC-49AD38C0A79A}"/>
          </ac:spMkLst>
        </pc:spChg>
        <pc:spChg chg="add mod">
          <ac:chgData name="Hirofumi HITOMI" userId="7f0fc49cc38f80df" providerId="LiveId" clId="{3A26AE82-3AEE-4B0A-AFBA-F08F7C421DB0}" dt="2024-05-20T00:32:11.101" v="0"/>
          <ac:spMkLst>
            <pc:docMk/>
            <pc:sldMk cId="4207108356" sldId="257"/>
            <ac:spMk id="19" creationId="{7CA4926E-EC36-9F1A-2B59-FE825DA71976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33" creationId="{FA3000E0-9598-A4DA-4EC5-207DF9B89DF0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35" creationId="{85C604C9-3C72-5B3A-7429-E15460B1BB27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36" creationId="{6D05460D-A2DC-4455-C089-083DE4D003D8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38" creationId="{C689F608-27E6-54AB-BDC0-741F1399BC6C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39" creationId="{68C1F986-C92C-3299-B976-56CDEB58AD57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40" creationId="{FFC54C2F-2F00-0FC9-5320-F28B362FDE1B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41" creationId="{22D8D66A-8A87-1E68-58DF-11AE52B86262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42" creationId="{5579C7AE-1A12-8387-D923-A222B19C564A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44" creationId="{7A4FDE9C-6179-56D8-A961-DE03D11D5CF7}"/>
          </ac:spMkLst>
        </pc:spChg>
        <pc:spChg chg="add mod">
          <ac:chgData name="Hirofumi HITOMI" userId="7f0fc49cc38f80df" providerId="LiveId" clId="{3A26AE82-3AEE-4B0A-AFBA-F08F7C421DB0}" dt="2024-05-20T00:41:10.700" v="67" actId="1076"/>
          <ac:spMkLst>
            <pc:docMk/>
            <pc:sldMk cId="4207108356" sldId="257"/>
            <ac:spMk id="45" creationId="{7D34E92B-2C72-3D36-FB57-E32AE25CDC3C}"/>
          </ac:spMkLst>
        </pc:spChg>
        <pc:picChg chg="add mod">
          <ac:chgData name="Hirofumi HITOMI" userId="7f0fc49cc38f80df" providerId="LiveId" clId="{3A26AE82-3AEE-4B0A-AFBA-F08F7C421DB0}" dt="2024-05-20T00:32:11.101" v="0"/>
          <ac:picMkLst>
            <pc:docMk/>
            <pc:sldMk cId="4207108356" sldId="257"/>
            <ac:picMk id="7" creationId="{7FD9E4CF-7646-7FC2-F3C0-97DDEB8C8997}"/>
          </ac:picMkLst>
        </pc:picChg>
        <pc:picChg chg="add mod">
          <ac:chgData name="Hirofumi HITOMI" userId="7f0fc49cc38f80df" providerId="LiveId" clId="{3A26AE82-3AEE-4B0A-AFBA-F08F7C421DB0}" dt="2024-05-20T00:32:11.101" v="0"/>
          <ac:picMkLst>
            <pc:docMk/>
            <pc:sldMk cId="4207108356" sldId="257"/>
            <ac:picMk id="9" creationId="{9A06563B-D77C-1114-F595-6BEE2445A311}"/>
          </ac:picMkLst>
        </pc:picChg>
        <pc:picChg chg="add mod">
          <ac:chgData name="Hirofumi HITOMI" userId="7f0fc49cc38f80df" providerId="LiveId" clId="{3A26AE82-3AEE-4B0A-AFBA-F08F7C421DB0}" dt="2024-05-20T00:32:11.101" v="0"/>
          <ac:picMkLst>
            <pc:docMk/>
            <pc:sldMk cId="4207108356" sldId="257"/>
            <ac:picMk id="11" creationId="{6E176525-613B-D3C7-C946-44C434280CFB}"/>
          </ac:picMkLst>
        </pc:picChg>
        <pc:picChg chg="add mod">
          <ac:chgData name="Hirofumi HITOMI" userId="7f0fc49cc38f80df" providerId="LiveId" clId="{3A26AE82-3AEE-4B0A-AFBA-F08F7C421DB0}" dt="2024-05-20T00:41:10.700" v="67" actId="1076"/>
          <ac:picMkLst>
            <pc:docMk/>
            <pc:sldMk cId="4207108356" sldId="257"/>
            <ac:picMk id="13" creationId="{FC6F4E4D-24BB-C04A-7D82-A068B8AD8E4D}"/>
          </ac:picMkLst>
        </pc:picChg>
        <pc:picChg chg="add mod">
          <ac:chgData name="Hirofumi HITOMI" userId="7f0fc49cc38f80df" providerId="LiveId" clId="{3A26AE82-3AEE-4B0A-AFBA-F08F7C421DB0}" dt="2024-05-20T00:41:10.700" v="67" actId="1076"/>
          <ac:picMkLst>
            <pc:docMk/>
            <pc:sldMk cId="4207108356" sldId="257"/>
            <ac:picMk id="15" creationId="{1D0AB80E-C28F-DEE8-8066-ECE7D59038EA}"/>
          </ac:picMkLst>
        </pc:picChg>
      </pc:sldChg>
      <pc:sldChg chg="addSp delSp modSp add mod">
        <pc:chgData name="Hirofumi HITOMI" userId="7f0fc49cc38f80df" providerId="LiveId" clId="{3A26AE82-3AEE-4B0A-AFBA-F08F7C421DB0}" dt="2024-05-20T00:40:58.903" v="65" actId="1076"/>
        <pc:sldMkLst>
          <pc:docMk/>
          <pc:sldMk cId="2145154725" sldId="258"/>
        </pc:sldMkLst>
        <pc:spChg chg="add mod">
          <ac:chgData name="Hirofumi HITOMI" userId="7f0fc49cc38f80df" providerId="LiveId" clId="{3A26AE82-3AEE-4B0A-AFBA-F08F7C421DB0}" dt="2024-05-20T00:40:58.903" v="65" actId="1076"/>
          <ac:spMkLst>
            <pc:docMk/>
            <pc:sldMk cId="2145154725" sldId="258"/>
            <ac:spMk id="2" creationId="{5073C896-2CB3-FC78-D18F-066F2D2E27BA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5" creationId="{A2473A78-E04B-5042-7E1C-0128227F7A80}"/>
          </ac:spMkLst>
        </pc:spChg>
        <pc:spChg chg="add mod">
          <ac:chgData name="Hirofumi HITOMI" userId="7f0fc49cc38f80df" providerId="LiveId" clId="{3A26AE82-3AEE-4B0A-AFBA-F08F7C421DB0}" dt="2024-05-20T00:40:58.903" v="65" actId="1076"/>
          <ac:spMkLst>
            <pc:docMk/>
            <pc:sldMk cId="2145154725" sldId="258"/>
            <ac:spMk id="12" creationId="{52CA5364-BBCE-750D-BC5D-37E3633A05D0}"/>
          </ac:spMkLst>
        </pc:spChg>
        <pc:spChg chg="add mod">
          <ac:chgData name="Hirofumi HITOMI" userId="7f0fc49cc38f80df" providerId="LiveId" clId="{3A26AE82-3AEE-4B0A-AFBA-F08F7C421DB0}" dt="2024-05-20T00:40:58.903" v="65" actId="1076"/>
          <ac:spMkLst>
            <pc:docMk/>
            <pc:sldMk cId="2145154725" sldId="258"/>
            <ac:spMk id="14" creationId="{01CC6308-A8DF-11CA-001A-92498890CED8}"/>
          </ac:spMkLst>
        </pc:spChg>
        <pc:spChg chg="add mod">
          <ac:chgData name="Hirofumi HITOMI" userId="7f0fc49cc38f80df" providerId="LiveId" clId="{3A26AE82-3AEE-4B0A-AFBA-F08F7C421DB0}" dt="2024-05-20T00:40:58.903" v="65" actId="1076"/>
          <ac:spMkLst>
            <pc:docMk/>
            <pc:sldMk cId="2145154725" sldId="258"/>
            <ac:spMk id="16" creationId="{82EA1425-0E06-8046-F30C-C6BD2AC61659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17" creationId="{015F0438-3DCF-8D55-1CCC-49AD38C0A79A}"/>
          </ac:spMkLst>
        </pc:spChg>
        <pc:spChg chg="add mod">
          <ac:chgData name="Hirofumi HITOMI" userId="7f0fc49cc38f80df" providerId="LiveId" clId="{3A26AE82-3AEE-4B0A-AFBA-F08F7C421DB0}" dt="2024-05-20T00:40:58.903" v="65" actId="1076"/>
          <ac:spMkLst>
            <pc:docMk/>
            <pc:sldMk cId="2145154725" sldId="258"/>
            <ac:spMk id="18" creationId="{DF501ADC-9E70-A93F-BAF4-43BA61A4E26C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19" creationId="{7CA4926E-EC36-9F1A-2B59-FE825DA71976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33" creationId="{FA3000E0-9598-A4DA-4EC5-207DF9B89DF0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35" creationId="{85C604C9-3C72-5B3A-7429-E15460B1BB27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36" creationId="{6D05460D-A2DC-4455-C089-083DE4D003D8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38" creationId="{C689F608-27E6-54AB-BDC0-741F1399BC6C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39" creationId="{68C1F986-C92C-3299-B976-56CDEB58AD57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40" creationId="{FFC54C2F-2F00-0FC9-5320-F28B362FDE1B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41" creationId="{22D8D66A-8A87-1E68-58DF-11AE52B86262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42" creationId="{5579C7AE-1A12-8387-D923-A222B19C564A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44" creationId="{7A4FDE9C-6179-56D8-A961-DE03D11D5CF7}"/>
          </ac:spMkLst>
        </pc:spChg>
        <pc:spChg chg="del">
          <ac:chgData name="Hirofumi HITOMI" userId="7f0fc49cc38f80df" providerId="LiveId" clId="{3A26AE82-3AEE-4B0A-AFBA-F08F7C421DB0}" dt="2024-05-20T00:33:50.301" v="33" actId="478"/>
          <ac:spMkLst>
            <pc:docMk/>
            <pc:sldMk cId="2145154725" sldId="258"/>
            <ac:spMk id="45" creationId="{7D34E92B-2C72-3D36-FB57-E32AE25CDC3C}"/>
          </ac:spMkLst>
        </pc:spChg>
        <pc:picChg chg="add mod">
          <ac:chgData name="Hirofumi HITOMI" userId="7f0fc49cc38f80df" providerId="LiveId" clId="{3A26AE82-3AEE-4B0A-AFBA-F08F7C421DB0}" dt="2024-05-20T00:40:58.903" v="65" actId="1076"/>
          <ac:picMkLst>
            <pc:docMk/>
            <pc:sldMk cId="2145154725" sldId="258"/>
            <ac:picMk id="3" creationId="{AC8043AA-DD37-F231-DFFE-D0E51BFA324E}"/>
          </ac:picMkLst>
        </pc:picChg>
        <pc:picChg chg="add mod">
          <ac:chgData name="Hirofumi HITOMI" userId="7f0fc49cc38f80df" providerId="LiveId" clId="{3A26AE82-3AEE-4B0A-AFBA-F08F7C421DB0}" dt="2024-05-20T00:40:58.903" v="65" actId="1076"/>
          <ac:picMkLst>
            <pc:docMk/>
            <pc:sldMk cId="2145154725" sldId="258"/>
            <ac:picMk id="4" creationId="{EDD2E46C-F9E5-7F56-49DA-97CB247963AC}"/>
          </ac:picMkLst>
        </pc:picChg>
        <pc:picChg chg="del">
          <ac:chgData name="Hirofumi HITOMI" userId="7f0fc49cc38f80df" providerId="LiveId" clId="{3A26AE82-3AEE-4B0A-AFBA-F08F7C421DB0}" dt="2024-05-20T00:33:50.301" v="33" actId="478"/>
          <ac:picMkLst>
            <pc:docMk/>
            <pc:sldMk cId="2145154725" sldId="258"/>
            <ac:picMk id="7" creationId="{7FD9E4CF-7646-7FC2-F3C0-97DDEB8C8997}"/>
          </ac:picMkLst>
        </pc:picChg>
        <pc:picChg chg="add mod">
          <ac:chgData name="Hirofumi HITOMI" userId="7f0fc49cc38f80df" providerId="LiveId" clId="{3A26AE82-3AEE-4B0A-AFBA-F08F7C421DB0}" dt="2024-05-20T00:40:58.903" v="65" actId="1076"/>
          <ac:picMkLst>
            <pc:docMk/>
            <pc:sldMk cId="2145154725" sldId="258"/>
            <ac:picMk id="8" creationId="{8C5433FB-105B-B687-7781-D74203559383}"/>
          </ac:picMkLst>
        </pc:picChg>
        <pc:picChg chg="del">
          <ac:chgData name="Hirofumi HITOMI" userId="7f0fc49cc38f80df" providerId="LiveId" clId="{3A26AE82-3AEE-4B0A-AFBA-F08F7C421DB0}" dt="2024-05-20T00:33:50.301" v="33" actId="478"/>
          <ac:picMkLst>
            <pc:docMk/>
            <pc:sldMk cId="2145154725" sldId="258"/>
            <ac:picMk id="9" creationId="{9A06563B-D77C-1114-F595-6BEE2445A311}"/>
          </ac:picMkLst>
        </pc:picChg>
        <pc:picChg chg="add mod">
          <ac:chgData name="Hirofumi HITOMI" userId="7f0fc49cc38f80df" providerId="LiveId" clId="{3A26AE82-3AEE-4B0A-AFBA-F08F7C421DB0}" dt="2024-05-20T00:40:58.903" v="65" actId="1076"/>
          <ac:picMkLst>
            <pc:docMk/>
            <pc:sldMk cId="2145154725" sldId="258"/>
            <ac:picMk id="10" creationId="{11A5E3D4-A3F5-1F80-FD78-F2A79FD6326E}"/>
          </ac:picMkLst>
        </pc:picChg>
        <pc:picChg chg="del">
          <ac:chgData name="Hirofumi HITOMI" userId="7f0fc49cc38f80df" providerId="LiveId" clId="{3A26AE82-3AEE-4B0A-AFBA-F08F7C421DB0}" dt="2024-05-20T00:33:50.301" v="33" actId="478"/>
          <ac:picMkLst>
            <pc:docMk/>
            <pc:sldMk cId="2145154725" sldId="258"/>
            <ac:picMk id="11" creationId="{6E176525-613B-D3C7-C946-44C434280CFB}"/>
          </ac:picMkLst>
        </pc:picChg>
        <pc:picChg chg="del">
          <ac:chgData name="Hirofumi HITOMI" userId="7f0fc49cc38f80df" providerId="LiveId" clId="{3A26AE82-3AEE-4B0A-AFBA-F08F7C421DB0}" dt="2024-05-20T00:33:50.301" v="33" actId="478"/>
          <ac:picMkLst>
            <pc:docMk/>
            <pc:sldMk cId="2145154725" sldId="258"/>
            <ac:picMk id="13" creationId="{FC6F4E4D-24BB-C04A-7D82-A068B8AD8E4D}"/>
          </ac:picMkLst>
        </pc:picChg>
        <pc:picChg chg="del">
          <ac:chgData name="Hirofumi HITOMI" userId="7f0fc49cc38f80df" providerId="LiveId" clId="{3A26AE82-3AEE-4B0A-AFBA-F08F7C421DB0}" dt="2024-05-20T00:33:50.301" v="33" actId="478"/>
          <ac:picMkLst>
            <pc:docMk/>
            <pc:sldMk cId="2145154725" sldId="258"/>
            <ac:picMk id="15" creationId="{1D0AB80E-C28F-DEE8-8066-ECE7D59038EA}"/>
          </ac:picMkLst>
        </pc:picChg>
      </pc:sldChg>
      <pc:sldChg chg="addSp delSp modSp add mod">
        <pc:chgData name="Hirofumi HITOMI" userId="7f0fc49cc38f80df" providerId="LiveId" clId="{3A26AE82-3AEE-4B0A-AFBA-F08F7C421DB0}" dt="2024-05-20T00:50:20.818" v="68" actId="20577"/>
        <pc:sldMkLst>
          <pc:docMk/>
          <pc:sldMk cId="1809952801" sldId="259"/>
        </pc:sldMkLst>
        <pc:spChg chg="add mod">
          <ac:chgData name="Hirofumi HITOMI" userId="7f0fc49cc38f80df" providerId="LiveId" clId="{3A26AE82-3AEE-4B0A-AFBA-F08F7C421DB0}" dt="2024-05-20T00:50:20.818" v="68" actId="20577"/>
          <ac:spMkLst>
            <pc:docMk/>
            <pc:sldMk cId="1809952801" sldId="259"/>
            <ac:spMk id="3" creationId="{9CB4FFD9-ED2D-B0E5-82F9-D4CF9BEFC3A2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5" creationId="{A2473A78-E04B-5042-7E1C-0128227F7A80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17" creationId="{015F0438-3DCF-8D55-1CCC-49AD38C0A79A}"/>
          </ac:spMkLst>
        </pc:spChg>
        <pc:spChg chg="add mod">
          <ac:chgData name="Hirofumi HITOMI" userId="7f0fc49cc38f80df" providerId="LiveId" clId="{3A26AE82-3AEE-4B0A-AFBA-F08F7C421DB0}" dt="2024-05-20T00:35:05.092" v="44" actId="1076"/>
          <ac:spMkLst>
            <pc:docMk/>
            <pc:sldMk cId="1809952801" sldId="259"/>
            <ac:spMk id="18" creationId="{145EEE0D-133F-03F9-3458-30077A18248D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19" creationId="{7CA4926E-EC36-9F1A-2B59-FE825DA71976}"/>
          </ac:spMkLst>
        </pc:spChg>
        <pc:spChg chg="add mod">
          <ac:chgData name="Hirofumi HITOMI" userId="7f0fc49cc38f80df" providerId="LiveId" clId="{3A26AE82-3AEE-4B0A-AFBA-F08F7C421DB0}" dt="2024-05-20T00:35:42.511" v="60" actId="1076"/>
          <ac:spMkLst>
            <pc:docMk/>
            <pc:sldMk cId="1809952801" sldId="259"/>
            <ac:spMk id="20" creationId="{73B10295-F953-FA7C-9347-1D6F0E4F5C3B}"/>
          </ac:spMkLst>
        </pc:spChg>
        <pc:spChg chg="add mod">
          <ac:chgData name="Hirofumi HITOMI" userId="7f0fc49cc38f80df" providerId="LiveId" clId="{3A26AE82-3AEE-4B0A-AFBA-F08F7C421DB0}" dt="2024-05-20T00:35:42.511" v="60" actId="1076"/>
          <ac:spMkLst>
            <pc:docMk/>
            <pc:sldMk cId="1809952801" sldId="259"/>
            <ac:spMk id="21" creationId="{2C795D91-3A19-661B-AA6F-532E4ECCCE54}"/>
          </ac:spMkLst>
        </pc:spChg>
        <pc:spChg chg="add mod">
          <ac:chgData name="Hirofumi HITOMI" userId="7f0fc49cc38f80df" providerId="LiveId" clId="{3A26AE82-3AEE-4B0A-AFBA-F08F7C421DB0}" dt="2024-05-20T00:35:42.511" v="60" actId="1076"/>
          <ac:spMkLst>
            <pc:docMk/>
            <pc:sldMk cId="1809952801" sldId="259"/>
            <ac:spMk id="22" creationId="{95990932-97A4-D10E-5F0A-863A22F828BF}"/>
          </ac:spMkLst>
        </pc:spChg>
        <pc:spChg chg="add mod">
          <ac:chgData name="Hirofumi HITOMI" userId="7f0fc49cc38f80df" providerId="LiveId" clId="{3A26AE82-3AEE-4B0A-AFBA-F08F7C421DB0}" dt="2024-05-20T00:35:42.511" v="60" actId="1076"/>
          <ac:spMkLst>
            <pc:docMk/>
            <pc:sldMk cId="1809952801" sldId="259"/>
            <ac:spMk id="23" creationId="{6E458A4B-F324-8FF0-9653-ACC37F9E8BB8}"/>
          </ac:spMkLst>
        </pc:spChg>
        <pc:spChg chg="add mod">
          <ac:chgData name="Hirofumi HITOMI" userId="7f0fc49cc38f80df" providerId="LiveId" clId="{3A26AE82-3AEE-4B0A-AFBA-F08F7C421DB0}" dt="2024-05-20T00:40:51.476" v="64" actId="20577"/>
          <ac:spMkLst>
            <pc:docMk/>
            <pc:sldMk cId="1809952801" sldId="259"/>
            <ac:spMk id="24" creationId="{C8512348-A122-A878-278E-2DEE0E215645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33" creationId="{FA3000E0-9598-A4DA-4EC5-207DF9B89DF0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35" creationId="{85C604C9-3C72-5B3A-7429-E15460B1BB27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36" creationId="{6D05460D-A2DC-4455-C089-083DE4D003D8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38" creationId="{C689F608-27E6-54AB-BDC0-741F1399BC6C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39" creationId="{68C1F986-C92C-3299-B976-56CDEB58AD57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40" creationId="{FFC54C2F-2F00-0FC9-5320-F28B362FDE1B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41" creationId="{22D8D66A-8A87-1E68-58DF-11AE52B86262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42" creationId="{5579C7AE-1A12-8387-D923-A222B19C564A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44" creationId="{7A4FDE9C-6179-56D8-A961-DE03D11D5CF7}"/>
          </ac:spMkLst>
        </pc:spChg>
        <pc:spChg chg="del">
          <ac:chgData name="Hirofumi HITOMI" userId="7f0fc49cc38f80df" providerId="LiveId" clId="{3A26AE82-3AEE-4B0A-AFBA-F08F7C421DB0}" dt="2024-05-20T00:33:42.402" v="32" actId="478"/>
          <ac:spMkLst>
            <pc:docMk/>
            <pc:sldMk cId="1809952801" sldId="259"/>
            <ac:spMk id="45" creationId="{7D34E92B-2C72-3D36-FB57-E32AE25CDC3C}"/>
          </ac:spMkLst>
        </pc:spChg>
        <pc:picChg chg="add mod">
          <ac:chgData name="Hirofumi HITOMI" userId="7f0fc49cc38f80df" providerId="LiveId" clId="{3A26AE82-3AEE-4B0A-AFBA-F08F7C421DB0}" dt="2024-05-20T00:35:42.511" v="60" actId="1076"/>
          <ac:picMkLst>
            <pc:docMk/>
            <pc:sldMk cId="1809952801" sldId="259"/>
            <ac:picMk id="2" creationId="{43972426-3178-DCAA-503E-96962377B3D8}"/>
          </ac:picMkLst>
        </pc:picChg>
        <pc:picChg chg="add mod">
          <ac:chgData name="Hirofumi HITOMI" userId="7f0fc49cc38f80df" providerId="LiveId" clId="{3A26AE82-3AEE-4B0A-AFBA-F08F7C421DB0}" dt="2024-05-20T00:35:42.511" v="60" actId="1076"/>
          <ac:picMkLst>
            <pc:docMk/>
            <pc:sldMk cId="1809952801" sldId="259"/>
            <ac:picMk id="4" creationId="{5F239B3B-724F-6480-5B0E-D3353314C825}"/>
          </ac:picMkLst>
        </pc:picChg>
        <pc:picChg chg="del">
          <ac:chgData name="Hirofumi HITOMI" userId="7f0fc49cc38f80df" providerId="LiveId" clId="{3A26AE82-3AEE-4B0A-AFBA-F08F7C421DB0}" dt="2024-05-20T00:33:42.402" v="32" actId="478"/>
          <ac:picMkLst>
            <pc:docMk/>
            <pc:sldMk cId="1809952801" sldId="259"/>
            <ac:picMk id="7" creationId="{7FD9E4CF-7646-7FC2-F3C0-97DDEB8C8997}"/>
          </ac:picMkLst>
        </pc:picChg>
        <pc:picChg chg="add mod">
          <ac:chgData name="Hirofumi HITOMI" userId="7f0fc49cc38f80df" providerId="LiveId" clId="{3A26AE82-3AEE-4B0A-AFBA-F08F7C421DB0}" dt="2024-05-20T00:35:05.092" v="44" actId="1076"/>
          <ac:picMkLst>
            <pc:docMk/>
            <pc:sldMk cId="1809952801" sldId="259"/>
            <ac:picMk id="8" creationId="{7ADAB4A1-991F-B2BF-D409-42C6121D7558}"/>
          </ac:picMkLst>
        </pc:picChg>
        <pc:picChg chg="del">
          <ac:chgData name="Hirofumi HITOMI" userId="7f0fc49cc38f80df" providerId="LiveId" clId="{3A26AE82-3AEE-4B0A-AFBA-F08F7C421DB0}" dt="2024-05-20T00:33:42.402" v="32" actId="478"/>
          <ac:picMkLst>
            <pc:docMk/>
            <pc:sldMk cId="1809952801" sldId="259"/>
            <ac:picMk id="9" creationId="{9A06563B-D77C-1114-F595-6BEE2445A311}"/>
          </ac:picMkLst>
        </pc:picChg>
        <pc:picChg chg="add mod">
          <ac:chgData name="Hirofumi HITOMI" userId="7f0fc49cc38f80df" providerId="LiveId" clId="{3A26AE82-3AEE-4B0A-AFBA-F08F7C421DB0}" dt="2024-05-20T00:35:05.092" v="44" actId="1076"/>
          <ac:picMkLst>
            <pc:docMk/>
            <pc:sldMk cId="1809952801" sldId="259"/>
            <ac:picMk id="10" creationId="{1A64EB30-47C9-99CE-1916-C92B07B46918}"/>
          </ac:picMkLst>
        </pc:picChg>
        <pc:picChg chg="del">
          <ac:chgData name="Hirofumi HITOMI" userId="7f0fc49cc38f80df" providerId="LiveId" clId="{3A26AE82-3AEE-4B0A-AFBA-F08F7C421DB0}" dt="2024-05-20T00:33:42.402" v="32" actId="478"/>
          <ac:picMkLst>
            <pc:docMk/>
            <pc:sldMk cId="1809952801" sldId="259"/>
            <ac:picMk id="11" creationId="{6E176525-613B-D3C7-C946-44C434280CFB}"/>
          </ac:picMkLst>
        </pc:picChg>
        <pc:picChg chg="add mod">
          <ac:chgData name="Hirofumi HITOMI" userId="7f0fc49cc38f80df" providerId="LiveId" clId="{3A26AE82-3AEE-4B0A-AFBA-F08F7C421DB0}" dt="2024-05-20T00:35:42.511" v="60" actId="1076"/>
          <ac:picMkLst>
            <pc:docMk/>
            <pc:sldMk cId="1809952801" sldId="259"/>
            <ac:picMk id="12" creationId="{07FA2AD8-1167-EE8A-46A9-6F54A9B83D42}"/>
          </ac:picMkLst>
        </pc:picChg>
        <pc:picChg chg="del">
          <ac:chgData name="Hirofumi HITOMI" userId="7f0fc49cc38f80df" providerId="LiveId" clId="{3A26AE82-3AEE-4B0A-AFBA-F08F7C421DB0}" dt="2024-05-20T00:33:42.402" v="32" actId="478"/>
          <ac:picMkLst>
            <pc:docMk/>
            <pc:sldMk cId="1809952801" sldId="259"/>
            <ac:picMk id="13" creationId="{FC6F4E4D-24BB-C04A-7D82-A068B8AD8E4D}"/>
          </ac:picMkLst>
        </pc:picChg>
        <pc:picChg chg="add mod">
          <ac:chgData name="Hirofumi HITOMI" userId="7f0fc49cc38f80df" providerId="LiveId" clId="{3A26AE82-3AEE-4B0A-AFBA-F08F7C421DB0}" dt="2024-05-20T00:35:05.092" v="44" actId="1076"/>
          <ac:picMkLst>
            <pc:docMk/>
            <pc:sldMk cId="1809952801" sldId="259"/>
            <ac:picMk id="14" creationId="{A28E72EB-5EA2-1761-8FEE-4ABBC75CA442}"/>
          </ac:picMkLst>
        </pc:picChg>
        <pc:picChg chg="del">
          <ac:chgData name="Hirofumi HITOMI" userId="7f0fc49cc38f80df" providerId="LiveId" clId="{3A26AE82-3AEE-4B0A-AFBA-F08F7C421DB0}" dt="2024-05-20T00:33:42.402" v="32" actId="478"/>
          <ac:picMkLst>
            <pc:docMk/>
            <pc:sldMk cId="1809952801" sldId="259"/>
            <ac:picMk id="15" creationId="{1D0AB80E-C28F-DEE8-8066-ECE7D59038EA}"/>
          </ac:picMkLst>
        </pc:picChg>
        <pc:picChg chg="add mod">
          <ac:chgData name="Hirofumi HITOMI" userId="7f0fc49cc38f80df" providerId="LiveId" clId="{3A26AE82-3AEE-4B0A-AFBA-F08F7C421DB0}" dt="2024-05-20T00:35:42.511" v="60" actId="1076"/>
          <ac:picMkLst>
            <pc:docMk/>
            <pc:sldMk cId="1809952801" sldId="259"/>
            <ac:picMk id="16" creationId="{EDF96590-AE86-6A33-0AA4-DAC7766DD3A5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50BEBB-C015-4B1D-9A41-EF46C0073217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E554F-8E08-4889-AF45-774C831087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09541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sz="1200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lang="en-US" altLang="ja-JP" sz="1200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BE554F-8E08-4889-AF45-774C8310875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48568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sz="1200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lang="en-US" altLang="ja-JP" sz="1200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BE554F-8E08-4889-AF45-774C8310875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36316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sz="1200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endParaRPr lang="en-US" altLang="ja-JP" sz="1200" kern="100" dirty="0">
              <a:solidFill>
                <a:prstClr val="black"/>
              </a:solidFill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5BE554F-8E08-4889-AF45-774C8310875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9837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8784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3934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864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26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68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877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725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282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5979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134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931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7C536C-0C2A-48FD-9059-EC32B5291594}" type="datetimeFigureOut">
              <a:rPr kumimoji="1" lang="ja-JP" altLang="en-US" smtClean="0"/>
              <a:t>2024/5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99EAAB-42F4-4300-92C9-F95A7A55D4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5764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png"/><Relationship Id="rId9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F0CD3D3-7973-BD46-A827-2ABF269A58E5}"/>
              </a:ext>
            </a:extLst>
          </p:cNvPr>
          <p:cNvSpPr txBox="1"/>
          <p:nvPr/>
        </p:nvSpPr>
        <p:spPr>
          <a:xfrm>
            <a:off x="4956385" y="9443870"/>
            <a:ext cx="17913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. 1. Okano M 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2473A78-E04B-5042-7E1C-0128227F7A80}"/>
              </a:ext>
            </a:extLst>
          </p:cNvPr>
          <p:cNvSpPr txBox="1"/>
          <p:nvPr/>
        </p:nvSpPr>
        <p:spPr>
          <a:xfrm>
            <a:off x="1086219" y="558284"/>
            <a:ext cx="55194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LB (65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　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TR (20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　 　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HNF4 (55)  (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7FD9E4CF-7646-7FC2-F3C0-97DDEB8C899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61525" y="1145918"/>
            <a:ext cx="2018271" cy="271025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9A06563B-D77C-1114-F595-6BEE2445A31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01844" y="1145918"/>
            <a:ext cx="1952674" cy="2061519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6E176525-613B-D3C7-C946-44C434280CF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15379" y="1020977"/>
            <a:ext cx="1886465" cy="307889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FC6F4E4D-24BB-C04A-7D82-A068B8AD8E4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2595"/>
          <a:stretch/>
        </p:blipFill>
        <p:spPr>
          <a:xfrm>
            <a:off x="1086219" y="5185999"/>
            <a:ext cx="1820562" cy="3012989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1D0AB80E-C28F-DEE8-8066-ECE7D59038E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85939" y="5461610"/>
            <a:ext cx="2627604" cy="2560542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15F0438-3DCF-8D55-1CCC-49AD38C0A79A}"/>
              </a:ext>
            </a:extLst>
          </p:cNvPr>
          <p:cNvSpPr txBox="1"/>
          <p:nvPr/>
        </p:nvSpPr>
        <p:spPr>
          <a:xfrm>
            <a:off x="2301852" y="2645890"/>
            <a:ext cx="5838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矢印: 右 18">
            <a:extLst>
              <a:ext uri="{FF2B5EF4-FFF2-40B4-BE49-F238E27FC236}">
                <a16:creationId xmlns:a16="http://schemas.microsoft.com/office/drawing/2014/main" id="{7CA4926E-EC36-9F1A-2B59-FE825DA71976}"/>
              </a:ext>
            </a:extLst>
          </p:cNvPr>
          <p:cNvSpPr/>
          <p:nvPr/>
        </p:nvSpPr>
        <p:spPr>
          <a:xfrm>
            <a:off x="4512506" y="1895475"/>
            <a:ext cx="162489" cy="133350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A3000E0-9598-A4DA-4EC5-207DF9B89DF0}"/>
              </a:ext>
            </a:extLst>
          </p:cNvPr>
          <p:cNvSpPr txBox="1"/>
          <p:nvPr/>
        </p:nvSpPr>
        <p:spPr>
          <a:xfrm>
            <a:off x="3206302" y="583439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5C604C9-3C72-5B3A-7429-E15460B1BB27}"/>
              </a:ext>
            </a:extLst>
          </p:cNvPr>
          <p:cNvSpPr txBox="1"/>
          <p:nvPr/>
        </p:nvSpPr>
        <p:spPr>
          <a:xfrm>
            <a:off x="3151571" y="5629679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98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D05460D-A2DC-4455-C089-083DE4D003D8}"/>
              </a:ext>
            </a:extLst>
          </p:cNvPr>
          <p:cNvSpPr txBox="1"/>
          <p:nvPr/>
        </p:nvSpPr>
        <p:spPr>
          <a:xfrm>
            <a:off x="3206302" y="6034450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689F608-27E6-54AB-BDC0-741F1399BC6C}"/>
              </a:ext>
            </a:extLst>
          </p:cNvPr>
          <p:cNvSpPr txBox="1"/>
          <p:nvPr/>
        </p:nvSpPr>
        <p:spPr>
          <a:xfrm>
            <a:off x="3206302" y="623450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8C1F986-C92C-3299-B976-56CDEB58AD57}"/>
              </a:ext>
            </a:extLst>
          </p:cNvPr>
          <p:cNvSpPr txBox="1"/>
          <p:nvPr/>
        </p:nvSpPr>
        <p:spPr>
          <a:xfrm>
            <a:off x="3206302" y="6434560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FC54C2F-2F00-0FC9-5320-F28B362FDE1B}"/>
              </a:ext>
            </a:extLst>
          </p:cNvPr>
          <p:cNvSpPr txBox="1"/>
          <p:nvPr/>
        </p:nvSpPr>
        <p:spPr>
          <a:xfrm>
            <a:off x="3206302" y="6744433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2D8D66A-8A87-1E68-58DF-11AE52B86262}"/>
              </a:ext>
            </a:extLst>
          </p:cNvPr>
          <p:cNvSpPr txBox="1"/>
          <p:nvPr/>
        </p:nvSpPr>
        <p:spPr>
          <a:xfrm>
            <a:off x="3206302" y="7196459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579C7AE-1A12-8387-D923-A222B19C564A}"/>
              </a:ext>
            </a:extLst>
          </p:cNvPr>
          <p:cNvSpPr txBox="1"/>
          <p:nvPr/>
        </p:nvSpPr>
        <p:spPr>
          <a:xfrm>
            <a:off x="3206302" y="7450229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kumimoji="1"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A4FDE9C-6179-56D8-A961-DE03D11D5CF7}"/>
              </a:ext>
            </a:extLst>
          </p:cNvPr>
          <p:cNvSpPr txBox="1"/>
          <p:nvPr/>
        </p:nvSpPr>
        <p:spPr>
          <a:xfrm>
            <a:off x="3111497" y="5349702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D34E92B-2C72-3D36-FB57-E32AE25CDC3C}"/>
              </a:ext>
            </a:extLst>
          </p:cNvPr>
          <p:cNvSpPr txBox="1"/>
          <p:nvPr/>
        </p:nvSpPr>
        <p:spPr>
          <a:xfrm>
            <a:off x="1100369" y="4783546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40)  (</a:t>
            </a:r>
            <a:r>
              <a:rPr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7108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F0CD3D3-7973-BD46-A827-2ABF269A58E5}"/>
              </a:ext>
            </a:extLst>
          </p:cNvPr>
          <p:cNvSpPr txBox="1"/>
          <p:nvPr/>
        </p:nvSpPr>
        <p:spPr>
          <a:xfrm>
            <a:off x="4956385" y="9443870"/>
            <a:ext cx="17913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. 1. Okano M 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073C896-2CB3-FC78-D18F-066F2D2E27BA}"/>
              </a:ext>
            </a:extLst>
          </p:cNvPr>
          <p:cNvSpPr txBox="1"/>
          <p:nvPr/>
        </p:nvSpPr>
        <p:spPr>
          <a:xfrm>
            <a:off x="1396209" y="1126491"/>
            <a:ext cx="4805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itrin (70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　　         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SS (45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C8043AA-DD37-F231-DFFE-D0E51BFA324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77707" y="1495823"/>
            <a:ext cx="2057121" cy="253694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EDD2E46C-F9E5-7F56-49DA-97CB247963A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55764" y="1505323"/>
            <a:ext cx="2173236" cy="253694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8C5433FB-105B-B687-7781-D7420355938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55764" y="5137002"/>
            <a:ext cx="2001493" cy="2597322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11A5E3D4-A3F5-1F80-FD78-F2A79FD6326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802"/>
          <a:stretch/>
        </p:blipFill>
        <p:spPr>
          <a:xfrm>
            <a:off x="454551" y="1528259"/>
            <a:ext cx="718621" cy="2472070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2CA5364-BBCE-750D-BC5D-37E3633A05D0}"/>
              </a:ext>
            </a:extLst>
          </p:cNvPr>
          <p:cNvSpPr txBox="1"/>
          <p:nvPr/>
        </p:nvSpPr>
        <p:spPr>
          <a:xfrm>
            <a:off x="1391914" y="235273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1CC6308-A8DF-11CA-001A-92498890CED8}"/>
              </a:ext>
            </a:extLst>
          </p:cNvPr>
          <p:cNvSpPr txBox="1"/>
          <p:nvPr/>
        </p:nvSpPr>
        <p:spPr>
          <a:xfrm>
            <a:off x="3680667" y="256921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2EA1425-0E06-8046-F30C-C6BD2AC61659}"/>
              </a:ext>
            </a:extLst>
          </p:cNvPr>
          <p:cNvSpPr txBox="1"/>
          <p:nvPr/>
        </p:nvSpPr>
        <p:spPr>
          <a:xfrm>
            <a:off x="1271247" y="644344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501ADC-9E70-A93F-BAF4-43BA61A4E26C}"/>
              </a:ext>
            </a:extLst>
          </p:cNvPr>
          <p:cNvSpPr txBox="1"/>
          <p:nvPr/>
        </p:nvSpPr>
        <p:spPr>
          <a:xfrm>
            <a:off x="1532643" y="4663074"/>
            <a:ext cx="2531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GAPDH (40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5154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F0CD3D3-7973-BD46-A827-2ABF269A58E5}"/>
              </a:ext>
            </a:extLst>
          </p:cNvPr>
          <p:cNvSpPr txBox="1"/>
          <p:nvPr/>
        </p:nvSpPr>
        <p:spPr>
          <a:xfrm>
            <a:off x="4956385" y="9443870"/>
            <a:ext cx="17913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Fig. 1. Okano M </a:t>
            </a:r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3972426-3178-DCAA-503E-96962377B3D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56896" y="1097724"/>
            <a:ext cx="1573427" cy="2875005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CB4FFD9-ED2D-B0E5-82F9-D4CF9BEFC3A2}"/>
              </a:ext>
            </a:extLst>
          </p:cNvPr>
          <p:cNvSpPr txBox="1"/>
          <p:nvPr/>
        </p:nvSpPr>
        <p:spPr>
          <a:xfrm>
            <a:off x="1320633" y="604141"/>
            <a:ext cx="5169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PS1 (165)   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TC (40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　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SL (52)  (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5F239B3B-724F-6480-5B0E-D3353314C82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5729" y="1299191"/>
            <a:ext cx="1095828" cy="247207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7ADAB4A1-991F-B2BF-D409-42C6121D755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06897" y="5888900"/>
            <a:ext cx="1878227" cy="2726725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1A64EB30-47C9-99CE-1916-C92B07B4691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3093" y="5933270"/>
            <a:ext cx="1779373" cy="287500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07FA2AD8-1167-EE8A-46A9-6F54A9B83D4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67566" y="1006685"/>
            <a:ext cx="1779373" cy="3045941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A28E72EB-5EA2-1761-8FEE-4ABBC75CA44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83094" y="5630267"/>
            <a:ext cx="2106583" cy="302363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EDF96590-AE86-6A33-0AA4-DAC7766DD3A5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791625" y="1097724"/>
            <a:ext cx="1721638" cy="2875007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45EEE0D-133F-03F9-3458-30077A18248D}"/>
              </a:ext>
            </a:extLst>
          </p:cNvPr>
          <p:cNvSpPr txBox="1"/>
          <p:nvPr/>
        </p:nvSpPr>
        <p:spPr>
          <a:xfrm>
            <a:off x="3855946" y="717251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矢印: 右 19">
            <a:extLst>
              <a:ext uri="{FF2B5EF4-FFF2-40B4-BE49-F238E27FC236}">
                <a16:creationId xmlns:a16="http://schemas.microsoft.com/office/drawing/2014/main" id="{73B10295-F953-FA7C-9347-1D6F0E4F5C3B}"/>
              </a:ext>
            </a:extLst>
          </p:cNvPr>
          <p:cNvSpPr/>
          <p:nvPr/>
        </p:nvSpPr>
        <p:spPr>
          <a:xfrm>
            <a:off x="2779586" y="2287322"/>
            <a:ext cx="162489" cy="133350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C795D91-3A19-661B-AA6F-532E4ECCCE54}"/>
              </a:ext>
            </a:extLst>
          </p:cNvPr>
          <p:cNvSpPr txBox="1"/>
          <p:nvPr/>
        </p:nvSpPr>
        <p:spPr>
          <a:xfrm>
            <a:off x="1043335" y="1974194"/>
            <a:ext cx="427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5990932-97A4-D10E-5F0A-863A22F828BF}"/>
              </a:ext>
            </a:extLst>
          </p:cNvPr>
          <p:cNvSpPr txBox="1"/>
          <p:nvPr/>
        </p:nvSpPr>
        <p:spPr>
          <a:xfrm>
            <a:off x="4107686" y="229335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E458A4B-F324-8FF0-9653-ACC37F9E8BB8}"/>
              </a:ext>
            </a:extLst>
          </p:cNvPr>
          <p:cNvSpPr txBox="1"/>
          <p:nvPr/>
        </p:nvSpPr>
        <p:spPr>
          <a:xfrm>
            <a:off x="4359047" y="206044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8512348-A122-A878-278E-2DEE0E215645}"/>
              </a:ext>
            </a:extLst>
          </p:cNvPr>
          <p:cNvSpPr txBox="1"/>
          <p:nvPr/>
        </p:nvSpPr>
        <p:spPr>
          <a:xfrm>
            <a:off x="1022008" y="5050465"/>
            <a:ext cx="5489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SL (52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　　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RG1 (40)</a:t>
            </a:r>
            <a:r>
              <a: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　     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GAPDH (40) (</a:t>
            </a:r>
            <a:r>
              <a:rPr kumimoji="1" lang="en-US" altLang="ja-JP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9952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 w="19050"/>
      </a:spPr>
      <a:bodyPr rtlCol="0" anchor="ctr"/>
      <a:lstStyle>
        <a:defPPr algn="ctr">
          <a:defRPr kumimoji="1"/>
        </a:defPPr>
      </a:lstStyle>
      <a:style>
        <a:lnRef idx="1">
          <a:schemeClr val="accent2"/>
        </a:lnRef>
        <a:fillRef idx="2">
          <a:schemeClr val="accent2"/>
        </a:fillRef>
        <a:effectRef idx="1">
          <a:schemeClr val="accent2"/>
        </a:effectRef>
        <a:fontRef idx="minor">
          <a:schemeClr val="dk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598</TotalTime>
  <Words>121</Words>
  <Application>Microsoft Office PowerPoint</Application>
  <PresentationFormat>A4 210 x 297 mm</PresentationFormat>
  <Paragraphs>29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村 優輝</dc:creator>
  <cp:lastModifiedBy>Hirofumi HITOMI</cp:lastModifiedBy>
  <cp:revision>49</cp:revision>
  <cp:lastPrinted>2023-08-22T07:57:11Z</cp:lastPrinted>
  <dcterms:created xsi:type="dcterms:W3CDTF">2023-02-04T04:30:44Z</dcterms:created>
  <dcterms:modified xsi:type="dcterms:W3CDTF">2024-05-20T00:50:33Z</dcterms:modified>
</cp:coreProperties>
</file>